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7E3889-2B90-2CB7-63CF-2030869D35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AE919E3E-6E7E-372A-978A-91FF3C8BB1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A2EEB05-1210-27F8-F047-3B6A1291E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513D8CE-3E65-D795-B319-9A0E8F270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76B13A7-A07D-5EF1-2CB8-4628522CD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2435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2B41631-CC3E-E03D-48C0-4BB6666F63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8F02D13-214F-B6E7-9055-F4160E487A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4230B30-65CB-FE70-FB61-812CB5A595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9D398F4-B4CB-21BB-80ED-9AFE02ADC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FF3F7B4-F9A8-7AB9-B9AE-7916AD70C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6469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3D4BF0F-51EC-07D9-A46C-CE6E8316E0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7AAA44A-18BA-6C01-1B94-C9408F49C5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1F49691-75E4-3B19-FF89-44549431D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E55FC34-F9EF-065B-0BD3-3FCAB132E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B5A3147-6CF0-5693-9DD2-87E3B2AC6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0944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0B6AB1A-6B99-0079-A394-2E5848954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279AED2-BF34-3BD4-4028-520F8D3B3D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8313FD6-934E-ABCB-4640-0C28C6C99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9B1EF78-6924-E231-F946-FAA71897D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BD8093A-3A7D-B021-1A17-6E2DAE8F5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2362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75D39D-CB15-47EB-B315-60328828A6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52121CD-C5DA-1E4F-37B8-DE558FFD3A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32F79F0-B3D7-BB56-C82F-63E42E897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1875AC9-8D21-14F5-1FF2-80F318C59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ECECA5C-A4E4-F810-062F-88FD85409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7621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2723C43-693F-7CD9-7307-2C7498F00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0F6E2B1-921B-EA51-D7FE-6C9EDB6458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1E52DA1-5A2A-CAE9-8740-DEA538E239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BADA7B8-DC5A-5A8F-CA8F-C90E0780D4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D85613F-5DD4-6A0B-2630-5C2ACB525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84C9EF9-7DA6-B1B3-9A77-A725A1CDE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7332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2358698-8FAA-9124-E345-5F1B62C018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228BB27-CB73-D08B-1993-384FAAB896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7C226AC-D7E3-1604-E0D7-551E5197BD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5D79D0A-01FF-AC3C-81A7-1D4883DA98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5B67738-16B5-B698-740B-2D12E3A81B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FE727DE-0A84-2252-AE97-51E98FC94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B75E9FF-1BFF-4001-B97A-D8AE4BFF6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F223A89-3E00-6AC5-A69E-4E70EED0E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5191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CD7203-C5D5-CF6F-F5B8-16B7A75040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BA84F77-1F5C-AF2F-EEF5-55D93245B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A269B94-41EF-B9F6-A455-A937DB87C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D254B49-8995-5413-8135-8C6E1F4C7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1894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26AC9D4-C4A5-A1C8-0DD1-68330B9E1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7F99A37-4D05-5957-2195-0C287F719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C1B2F41-C91A-7C4D-FA46-C60E0E99A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7500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75E08FB-C7D0-EE72-10D4-8799D6A71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9B384A0-2FA7-448F-1BE1-4C72EBE5A8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36E4913-A694-1DD4-7D2D-0A297DD421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B1EBEDB-4672-2486-6418-250294162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B6D15BA-74BC-5360-A78C-79BD43C03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2D93BEA-F55B-CD4C-90FA-C0A473F87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087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51D2810-17A1-0677-D7C0-E17556FC8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8715309E-F9FA-5D73-8FA6-6E369724F99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DDBAA9E-77E9-CDE4-E07A-7C01FC86FC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390A8A9-08D0-CB27-CB49-8190DFE7C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A05350C-327F-4020-67DF-A035A31B1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79008E8-5627-4D23-EA8C-2D378CD58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6873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5DB6D88-9B96-321F-AB5F-D665E56826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2784CD5-D6C7-1789-8EF9-7389E5828B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FB808DD-E71F-6353-C483-D263A0B5401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7ACA57E-4B20-4750-81E4-7D09F3A53860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22D85C1-53A6-A5A9-E1AA-9E465935E1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9DA742D-3E8D-E6D5-3917-0B9AC3F8BF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F1A98E-AC12-41A5-8C55-9F42ECBD6C6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0410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6A8581F6-1DAE-8BD4-DFB1-2AAF94D0E095}"/>
              </a:ext>
            </a:extLst>
          </p:cNvPr>
          <p:cNvSpPr txBox="1"/>
          <p:nvPr/>
        </p:nvSpPr>
        <p:spPr>
          <a:xfrm>
            <a:off x="474732" y="615229"/>
            <a:ext cx="11638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 S3a. Score plot of OPLSDA showing patients on and off diet (points containing white asterisks)</a:t>
            </a:r>
            <a:endParaRPr lang="fr-FR" dirty="0"/>
          </a:p>
        </p:txBody>
      </p:sp>
      <p:grpSp>
        <p:nvGrpSpPr>
          <p:cNvPr id="16" name="Groupe 15">
            <a:extLst>
              <a:ext uri="{FF2B5EF4-FFF2-40B4-BE49-F238E27FC236}">
                <a16:creationId xmlns:a16="http://schemas.microsoft.com/office/drawing/2014/main" id="{6C2FE4C1-54D7-3018-E880-CDBA5BD5000D}"/>
              </a:ext>
            </a:extLst>
          </p:cNvPr>
          <p:cNvGrpSpPr/>
          <p:nvPr/>
        </p:nvGrpSpPr>
        <p:grpSpPr>
          <a:xfrm>
            <a:off x="1809748" y="915996"/>
            <a:ext cx="8572500" cy="4469228"/>
            <a:chOff x="1809748" y="915996"/>
            <a:chExt cx="8572500" cy="4469228"/>
          </a:xfrm>
        </p:grpSpPr>
        <p:grpSp>
          <p:nvGrpSpPr>
            <p:cNvPr id="2" name="Groupe 1">
              <a:extLst>
                <a:ext uri="{FF2B5EF4-FFF2-40B4-BE49-F238E27FC236}">
                  <a16:creationId xmlns:a16="http://schemas.microsoft.com/office/drawing/2014/main" id="{E7EFBA2D-F8CC-EFF3-E718-0DEFFEE42347}"/>
                </a:ext>
              </a:extLst>
            </p:cNvPr>
            <p:cNvGrpSpPr/>
            <p:nvPr/>
          </p:nvGrpSpPr>
          <p:grpSpPr>
            <a:xfrm>
              <a:off x="1809748" y="1098974"/>
              <a:ext cx="8572500" cy="4286250"/>
              <a:chOff x="1809750" y="1285875"/>
              <a:chExt cx="8572500" cy="4286250"/>
            </a:xfrm>
          </p:grpSpPr>
          <p:pic>
            <p:nvPicPr>
              <p:cNvPr id="3" name="Image 2">
                <a:extLst>
                  <a:ext uri="{FF2B5EF4-FFF2-40B4-BE49-F238E27FC236}">
                    <a16:creationId xmlns:a16="http://schemas.microsoft.com/office/drawing/2014/main" id="{D8EC9A1C-4475-7E0B-07BE-C80835FA31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09750" y="1285875"/>
                <a:ext cx="8572500" cy="4286250"/>
              </a:xfrm>
              <a:prstGeom prst="rect">
                <a:avLst/>
              </a:prstGeom>
            </p:spPr>
          </p:pic>
          <p:sp>
            <p:nvSpPr>
              <p:cNvPr id="9" name="ZoneTexte 8">
                <a:extLst>
                  <a:ext uri="{FF2B5EF4-FFF2-40B4-BE49-F238E27FC236}">
                    <a16:creationId xmlns:a16="http://schemas.microsoft.com/office/drawing/2014/main" id="{61DAA067-C88C-12C2-A6DE-737944F8DB5E}"/>
                  </a:ext>
                </a:extLst>
              </p:cNvPr>
              <p:cNvSpPr txBox="1"/>
              <p:nvPr/>
            </p:nvSpPr>
            <p:spPr>
              <a:xfrm>
                <a:off x="6894576" y="1797939"/>
                <a:ext cx="300837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0" name="ZoneTexte 9">
                <a:extLst>
                  <a:ext uri="{FF2B5EF4-FFF2-40B4-BE49-F238E27FC236}">
                    <a16:creationId xmlns:a16="http://schemas.microsoft.com/office/drawing/2014/main" id="{874F3920-2DE7-EB85-5920-53412F830098}"/>
                  </a:ext>
                </a:extLst>
              </p:cNvPr>
              <p:cNvSpPr txBox="1"/>
              <p:nvPr/>
            </p:nvSpPr>
            <p:spPr>
              <a:xfrm>
                <a:off x="6708648" y="2099917"/>
                <a:ext cx="300837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1" name="ZoneTexte 10">
                <a:extLst>
                  <a:ext uri="{FF2B5EF4-FFF2-40B4-BE49-F238E27FC236}">
                    <a16:creationId xmlns:a16="http://schemas.microsoft.com/office/drawing/2014/main" id="{F6416F6C-ECB6-41BB-9530-E13C91F4AD94}"/>
                  </a:ext>
                </a:extLst>
              </p:cNvPr>
              <p:cNvSpPr txBox="1"/>
              <p:nvPr/>
            </p:nvSpPr>
            <p:spPr>
              <a:xfrm>
                <a:off x="7080504" y="2371189"/>
                <a:ext cx="300837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2" name="ZoneTexte 11">
                <a:extLst>
                  <a:ext uri="{FF2B5EF4-FFF2-40B4-BE49-F238E27FC236}">
                    <a16:creationId xmlns:a16="http://schemas.microsoft.com/office/drawing/2014/main" id="{034BDBE6-93B9-E904-DC14-6670FFB490AB}"/>
                  </a:ext>
                </a:extLst>
              </p:cNvPr>
              <p:cNvSpPr txBox="1"/>
              <p:nvPr/>
            </p:nvSpPr>
            <p:spPr>
              <a:xfrm>
                <a:off x="6876288" y="2485602"/>
                <a:ext cx="300837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3" name="ZoneTexte 12">
                <a:extLst>
                  <a:ext uri="{FF2B5EF4-FFF2-40B4-BE49-F238E27FC236}">
                    <a16:creationId xmlns:a16="http://schemas.microsoft.com/office/drawing/2014/main" id="{7D04C767-34B5-F1FB-1E52-09D2E3CFB5A1}"/>
                  </a:ext>
                </a:extLst>
              </p:cNvPr>
              <p:cNvSpPr txBox="1"/>
              <p:nvPr/>
            </p:nvSpPr>
            <p:spPr>
              <a:xfrm>
                <a:off x="7043928" y="2975214"/>
                <a:ext cx="300837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707A80FF-ADD0-80FE-9F51-D397890F26B8}"/>
                  </a:ext>
                </a:extLst>
              </p:cNvPr>
              <p:cNvSpPr txBox="1"/>
              <p:nvPr/>
            </p:nvSpPr>
            <p:spPr>
              <a:xfrm>
                <a:off x="6620256" y="3287155"/>
                <a:ext cx="300837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  <p:sp>
            <p:nvSpPr>
              <p:cNvPr id="15" name="ZoneTexte 14">
                <a:extLst>
                  <a:ext uri="{FF2B5EF4-FFF2-40B4-BE49-F238E27FC236}">
                    <a16:creationId xmlns:a16="http://schemas.microsoft.com/office/drawing/2014/main" id="{AC3225CE-A37B-333A-D5B7-5562D033F4E3}"/>
                  </a:ext>
                </a:extLst>
              </p:cNvPr>
              <p:cNvSpPr txBox="1"/>
              <p:nvPr/>
            </p:nvSpPr>
            <p:spPr>
              <a:xfrm>
                <a:off x="7184136" y="3855423"/>
                <a:ext cx="300837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>
                    <a:solidFill>
                      <a:schemeClr val="bg1"/>
                    </a:solidFill>
                  </a:rPr>
                  <a:t>*</a:t>
                </a:r>
              </a:p>
            </p:txBody>
          </p:sp>
        </p:grp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751D39B4-CCDA-5483-33E1-7E3ABC937A0F}"/>
                </a:ext>
              </a:extLst>
            </p:cNvPr>
            <p:cNvSpPr/>
            <p:nvPr/>
          </p:nvSpPr>
          <p:spPr>
            <a:xfrm>
              <a:off x="3424426" y="915996"/>
              <a:ext cx="4892040" cy="7132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</p:spTree>
    <p:extLst>
      <p:ext uri="{BB962C8B-B14F-4D97-AF65-F5344CB8AC3E}">
        <p14:creationId xmlns:p14="http://schemas.microsoft.com/office/powerpoint/2010/main" val="10944193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3B212C-5D09-4DB7-9DB9-C1CA837245D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574294AC-3D5E-752B-5604-8E59D4941928}"/>
              </a:ext>
            </a:extLst>
          </p:cNvPr>
          <p:cNvSpPr txBox="1"/>
          <p:nvPr/>
        </p:nvSpPr>
        <p:spPr>
          <a:xfrm>
            <a:off x="630098" y="623399"/>
            <a:ext cx="102738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 S3b. Score plot of PLS to explain </a:t>
            </a:r>
            <a:r>
              <a:rPr lang="en-US" dirty="0" err="1"/>
              <a:t>Phe</a:t>
            </a:r>
            <a:r>
              <a:rPr lang="en-US" dirty="0"/>
              <a:t> showing patients off (red dots) and on diet (green dots)</a:t>
            </a:r>
            <a:endParaRPr lang="fr-FR" dirty="0"/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958B656E-000C-9A12-F8B8-C1141CF3133C}"/>
              </a:ext>
            </a:extLst>
          </p:cNvPr>
          <p:cNvGrpSpPr/>
          <p:nvPr/>
        </p:nvGrpSpPr>
        <p:grpSpPr>
          <a:xfrm>
            <a:off x="2193798" y="919039"/>
            <a:ext cx="8572500" cy="4359942"/>
            <a:chOff x="2119154" y="932688"/>
            <a:chExt cx="8572500" cy="4359942"/>
          </a:xfrm>
        </p:grpSpPr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BFF6ED71-DC7F-9369-69CA-BEB8179E8C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19154" y="1006380"/>
              <a:ext cx="8572500" cy="4286250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331C1619-F5E9-B818-FE77-6222B8B8C4AC}"/>
                </a:ext>
              </a:extLst>
            </p:cNvPr>
            <p:cNvSpPr/>
            <p:nvPr/>
          </p:nvSpPr>
          <p:spPr>
            <a:xfrm>
              <a:off x="4014216" y="932688"/>
              <a:ext cx="4123944" cy="5303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4219216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94637511-48A9-6716-58A0-6007F7A46755}"/>
              </a:ext>
            </a:extLst>
          </p:cNvPr>
          <p:cNvSpPr txBox="1"/>
          <p:nvPr/>
        </p:nvSpPr>
        <p:spPr>
          <a:xfrm>
            <a:off x="541608" y="548883"/>
            <a:ext cx="10362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 S3c. Score plot of PLS to explain Tyr showing patients off (red dots) and off diet (green dots)</a:t>
            </a:r>
            <a:endParaRPr lang="fr-FR" dirty="0"/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77CADC92-B8AB-02B8-DFF0-52F365A45C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9750" y="1006380"/>
            <a:ext cx="8572500" cy="4286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33278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</TotalTime>
  <Words>74</Words>
  <Application>Microsoft Office PowerPoint</Application>
  <PresentationFormat>Grand écran</PresentationFormat>
  <Paragraphs>10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n Dos Santos</dc:creator>
  <cp:lastModifiedBy>Yann Dos Santos</cp:lastModifiedBy>
  <cp:revision>3</cp:revision>
  <dcterms:created xsi:type="dcterms:W3CDTF">2025-02-06T15:35:40Z</dcterms:created>
  <dcterms:modified xsi:type="dcterms:W3CDTF">2025-03-17T13:43:12Z</dcterms:modified>
</cp:coreProperties>
</file>